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8" d="100"/>
          <a:sy n="68" d="100"/>
        </p:scale>
        <p:origin x="1446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B13F9B-2575-4CB0-B173-420061701C7C}" type="datetimeFigureOut">
              <a:rPr lang="zh-CN" altLang="en-US" smtClean="0"/>
              <a:t>2021/11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B9DDA-4797-42F0-A12F-E6F3699A8AB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137704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B13F9B-2575-4CB0-B173-420061701C7C}" type="datetimeFigureOut">
              <a:rPr lang="zh-CN" altLang="en-US" smtClean="0"/>
              <a:t>2021/11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B9DDA-4797-42F0-A12F-E6F3699A8AB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616423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B13F9B-2575-4CB0-B173-420061701C7C}" type="datetimeFigureOut">
              <a:rPr lang="zh-CN" altLang="en-US" smtClean="0"/>
              <a:t>2021/11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B9DDA-4797-42F0-A12F-E6F3699A8AB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606314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B13F9B-2575-4CB0-B173-420061701C7C}" type="datetimeFigureOut">
              <a:rPr lang="zh-CN" altLang="en-US" smtClean="0"/>
              <a:t>2021/11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B9DDA-4797-42F0-A12F-E6F3699A8AB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440655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B13F9B-2575-4CB0-B173-420061701C7C}" type="datetimeFigureOut">
              <a:rPr lang="zh-CN" altLang="en-US" smtClean="0"/>
              <a:t>2021/11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B9DDA-4797-42F0-A12F-E6F3699A8AB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66638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B13F9B-2575-4CB0-B173-420061701C7C}" type="datetimeFigureOut">
              <a:rPr lang="zh-CN" altLang="en-US" smtClean="0"/>
              <a:t>2021/11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B9DDA-4797-42F0-A12F-E6F3699A8AB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893921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B13F9B-2575-4CB0-B173-420061701C7C}" type="datetimeFigureOut">
              <a:rPr lang="zh-CN" altLang="en-US" smtClean="0"/>
              <a:t>2021/11/1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B9DDA-4797-42F0-A12F-E6F3699A8AB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662141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B13F9B-2575-4CB0-B173-420061701C7C}" type="datetimeFigureOut">
              <a:rPr lang="zh-CN" altLang="en-US" smtClean="0"/>
              <a:t>2021/11/1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B9DDA-4797-42F0-A12F-E6F3699A8AB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117095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B13F9B-2575-4CB0-B173-420061701C7C}" type="datetimeFigureOut">
              <a:rPr lang="zh-CN" altLang="en-US" smtClean="0"/>
              <a:t>2021/11/1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B9DDA-4797-42F0-A12F-E6F3699A8AB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873215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B13F9B-2575-4CB0-B173-420061701C7C}" type="datetimeFigureOut">
              <a:rPr lang="zh-CN" altLang="en-US" smtClean="0"/>
              <a:t>2021/11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B9DDA-4797-42F0-A12F-E6F3699A8AB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381144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B13F9B-2575-4CB0-B173-420061701C7C}" type="datetimeFigureOut">
              <a:rPr lang="zh-CN" altLang="en-US" smtClean="0"/>
              <a:t>2021/11/1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B9DDA-4797-42F0-A12F-E6F3699A8AB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619189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B13F9B-2575-4CB0-B173-420061701C7C}" type="datetimeFigureOut">
              <a:rPr lang="zh-CN" altLang="en-US" smtClean="0"/>
              <a:t>2021/11/1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CB9DDA-4797-42F0-A12F-E6F3699A8AB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076728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39E40549-EEEB-454D-952A-C63AF2B2BE04}"/>
              </a:ext>
            </a:extLst>
          </p:cNvPr>
          <p:cNvSpPr txBox="1"/>
          <p:nvPr/>
        </p:nvSpPr>
        <p:spPr>
          <a:xfrm>
            <a:off x="62345" y="5853858"/>
            <a:ext cx="9019309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Figure S 1: Amino acid Sequence Homology Alignment Results of G. </a:t>
            </a:r>
            <a:r>
              <a:rPr lang="en-US" altLang="zh-CN" dirty="0" err="1"/>
              <a:t>pentaphyllum</a:t>
            </a:r>
            <a:r>
              <a:rPr lang="en-US" altLang="zh-CN" dirty="0"/>
              <a:t> CYPs.</a:t>
            </a:r>
          </a:p>
          <a:p>
            <a:r>
              <a:rPr lang="en-US" altLang="zh-CN" dirty="0"/>
              <a:t>The blue box is the </a:t>
            </a:r>
            <a:r>
              <a:rPr lang="en-US" altLang="zh-CN" dirty="0" err="1"/>
              <a:t>AGxDTT</a:t>
            </a:r>
            <a:r>
              <a:rPr lang="en-US" altLang="zh-CN" dirty="0"/>
              <a:t> motif, the green box is the </a:t>
            </a:r>
            <a:r>
              <a:rPr lang="en-US" altLang="zh-CN" dirty="0" err="1"/>
              <a:t>ExxR</a:t>
            </a:r>
            <a:r>
              <a:rPr lang="en-US" altLang="zh-CN" dirty="0"/>
              <a:t> motif, the purple box is the PER motif, and the red box is the </a:t>
            </a:r>
            <a:r>
              <a:rPr lang="en-US" altLang="zh-CN" dirty="0" err="1"/>
              <a:t>FxxGxRxCxG</a:t>
            </a:r>
            <a:r>
              <a:rPr lang="en-US" altLang="zh-CN" dirty="0"/>
              <a:t> motif.</a:t>
            </a: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E2CA7C0B-E270-4A9F-8355-04A6D5A3E57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64383" y="204619"/>
            <a:ext cx="4919945" cy="55567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545159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</TotalTime>
  <Words>49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​​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hen Qicong</dc:creator>
  <cp:lastModifiedBy>HYD OFF33</cp:lastModifiedBy>
  <cp:revision>3</cp:revision>
  <dcterms:created xsi:type="dcterms:W3CDTF">2021-03-16T01:14:08Z</dcterms:created>
  <dcterms:modified xsi:type="dcterms:W3CDTF">2021-11-16T01:53:28Z</dcterms:modified>
</cp:coreProperties>
</file>